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02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1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54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4041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6993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043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9022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677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0924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4059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7230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8799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53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3786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090" y="3752654"/>
            <a:ext cx="4379490" cy="297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090" y="650648"/>
            <a:ext cx="3400001" cy="30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6287" y="650648"/>
            <a:ext cx="3834310" cy="30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2028" y="3750854"/>
            <a:ext cx="3627437" cy="297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feld 3"/>
          <p:cNvSpPr txBox="1">
            <a:spLocks noChangeArrowheads="1"/>
          </p:cNvSpPr>
          <p:nvPr/>
        </p:nvSpPr>
        <p:spPr bwMode="auto">
          <a:xfrm>
            <a:off x="360000" y="108000"/>
            <a:ext cx="114480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Bone marrow finding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roscopic pictures of the bone marrow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tected a therapy-related acute myeloid leukemia (AML) with prior myelo­dys­plastic changes. Cytogenetic detected monosomy 7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0255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Universitätsklinikum Ul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lies Götz</dc:creator>
  <cp:lastModifiedBy>Marlies Götz</cp:lastModifiedBy>
  <cp:revision>157</cp:revision>
  <cp:lastPrinted>2020-04-28T12:01:04Z</cp:lastPrinted>
  <dcterms:created xsi:type="dcterms:W3CDTF">2020-04-16T08:31:58Z</dcterms:created>
  <dcterms:modified xsi:type="dcterms:W3CDTF">2020-09-04T12:00:02Z</dcterms:modified>
</cp:coreProperties>
</file>